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15138" cy="99425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uario" initials="u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4" d="100"/>
          <a:sy n="84" d="100"/>
        </p:scale>
        <p:origin x="-660" y="5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15/09/2017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3 Tabla"/>
          <p:cNvGraphicFramePr>
            <a:graphicFrameLocks noGrp="1"/>
          </p:cNvGraphicFramePr>
          <p:nvPr/>
        </p:nvGraphicFramePr>
        <p:xfrm>
          <a:off x="251520" y="676055"/>
          <a:ext cx="8461340" cy="5356942"/>
        </p:xfrm>
        <a:graphic>
          <a:graphicData uri="http://schemas.openxmlformats.org/drawingml/2006/table">
            <a:tbl>
              <a:tblPr/>
              <a:tblGrid>
                <a:gridCol w="1053482"/>
                <a:gridCol w="1379895"/>
                <a:gridCol w="1492994"/>
                <a:gridCol w="1412049"/>
                <a:gridCol w="1597773"/>
                <a:gridCol w="1525147"/>
              </a:tblGrid>
              <a:tr h="504056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reatment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TPA-extractable soil </a:t>
                      </a:r>
                      <a:r>
                        <a:rPr lang="en-GB" sz="1100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(mg kg</a:t>
                      </a:r>
                      <a:r>
                        <a:rPr lang="en-GB" sz="1100" baseline="300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TPA-extractable soil Zn (mg kg</a:t>
                      </a:r>
                      <a:r>
                        <a:rPr lang="en-GB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oot DW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(g plant</a:t>
                      </a:r>
                      <a:r>
                        <a:rPr lang="es-ES" sz="1100" baseline="300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oot length (cm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verage root diameter (mm)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33588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No-Cd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*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8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0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9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46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</a:t>
                      </a: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8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78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4 </a:t>
                      </a:r>
                      <a:r>
                        <a:rPr lang="en-GB" sz="1100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709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9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08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51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5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7405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.3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  <a:endParaRPr lang="es-ES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2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3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6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b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2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21 </a:t>
                      </a:r>
                      <a:r>
                        <a:rPr lang="es-ES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9 </a:t>
                      </a: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endParaRPr lang="es-E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64 </a:t>
                      </a:r>
                      <a:r>
                        <a:rPr lang="es-ES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5 </a:t>
                      </a: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c</a:t>
                      </a:r>
                      <a:endParaRPr lang="es-E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73 </a:t>
                      </a:r>
                      <a:r>
                        <a:rPr lang="es-ES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37 </a:t>
                      </a:r>
                      <a:r>
                        <a:rPr lang="en-GB" sz="110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c</a:t>
                      </a:r>
                      <a:endParaRPr lang="es-ES" sz="110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4250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1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</a:t>
                      </a:r>
                      <a:endParaRPr lang="es-ES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9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8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34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2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3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 </a:t>
                      </a:r>
                      <a:r>
                        <a:rPr lang="en-GB" sz="11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51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1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27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8 </a:t>
                      </a:r>
                      <a:r>
                        <a:rPr lang="en-GB" sz="11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74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41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6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4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28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4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0941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b="1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reatment 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Shoot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DW </a:t>
                      </a: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(g plant</a:t>
                      </a:r>
                      <a:r>
                        <a:rPr lang="es-ES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-1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)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concentration (mg kg</a:t>
                      </a:r>
                      <a:r>
                        <a:rPr lang="en-GB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Zn concentration (mg kg</a:t>
                      </a:r>
                      <a:r>
                        <a:rPr lang="en-GB" sz="1100" baseline="300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hytate:Zn</a:t>
                      </a:r>
                      <a:r>
                        <a:rPr lang="en-GB" sz="11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ratio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hoot </a:t>
                      </a:r>
                      <a:r>
                        <a:rPr lang="en-GB" sz="1100" baseline="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protein </a:t>
                      </a: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oncentration (g kg</a:t>
                      </a:r>
                      <a:r>
                        <a:rPr lang="en-GB" sz="1100" baseline="300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1</a:t>
                      </a: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)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48072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No-Cd 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5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&lt;</a:t>
                      </a:r>
                      <a:r>
                        <a:rPr lang="es-ES" sz="1100" dirty="0" err="1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.l.</a:t>
                      </a:r>
                      <a:r>
                        <a:rPr lang="es-ES" sz="110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**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9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51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7</a:t>
                      </a:r>
                      <a:endParaRPr lang="en-GB" sz="1100" dirty="0" smtClean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9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0</a:t>
                      </a: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7.2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2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 </a:t>
                      </a: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.1 </a:t>
                      </a:r>
                      <a:r>
                        <a:rPr lang="es-ES" sz="1100" dirty="0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3 </a:t>
                      </a:r>
                      <a:r>
                        <a:rPr lang="en-GB" sz="1100" dirty="0" err="1">
                          <a:solidFill>
                            <a:schemeClr val="tx1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endParaRPr lang="es-ES" sz="1100" dirty="0">
                        <a:solidFill>
                          <a:schemeClr val="tx1"/>
                        </a:solidFill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9.1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3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6.5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2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2.3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.1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644215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4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2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94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4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5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8 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03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9 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54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3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47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40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1.3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3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4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8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5 </a:t>
                      </a:r>
                      <a:r>
                        <a:rPr lang="en-GB" sz="1100" dirty="0" err="1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2.1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8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8.3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7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1.3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7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57992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b="1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-C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No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2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      0.5-Zn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0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3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2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0.11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01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9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9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85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1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17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7 a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9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9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58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7</a:t>
                      </a:r>
                      <a:endParaRPr lang="en-GB" sz="1100" dirty="0" smtClean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82</a:t>
                      </a: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9</a:t>
                      </a: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1.4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8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b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.2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2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.3 </a:t>
                      </a:r>
                      <a:r>
                        <a:rPr lang="es-ES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0.1 </a:t>
                      </a:r>
                      <a:r>
                        <a:rPr lang="en-GB" sz="1100" dirty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294" marR="7294" marT="72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8.6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39.5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2.1</a:t>
                      </a:r>
                      <a:endParaRPr lang="es-ES" sz="1100" dirty="0" smtClean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s-ES" sz="1100" dirty="0" smtClean="0">
                          <a:latin typeface="Times New Roman" pitchFamily="18" charset="0"/>
                          <a:ea typeface="Calibri"/>
                          <a:cs typeface="Times New Roman" pitchFamily="18" charset="0"/>
                        </a:rPr>
                        <a:t>40.4 </a:t>
                      </a:r>
                      <a:r>
                        <a:rPr lang="es-ES" sz="1100" dirty="0" smtClean="0"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± 1.0</a:t>
                      </a:r>
                      <a:endParaRPr lang="es-ES" sz="1100" dirty="0">
                        <a:latin typeface="Times New Roman" pitchFamily="18" charset="0"/>
                        <a:ea typeface="Calibri"/>
                        <a:cs typeface="Times New Roman" pitchFamily="18" charset="0"/>
                      </a:endParaRPr>
                    </a:p>
                  </a:txBody>
                  <a:tcPr marL="70019" marR="70019" marT="35009" marB="35009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0" y="44624"/>
            <a:ext cx="8892480" cy="613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2</a:t>
            </a:r>
            <a:r>
              <a:rPr kumimoji="0" lang="en-GB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able.</a:t>
            </a:r>
            <a:r>
              <a:rPr lang="en-GB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GB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Mean ± standard error of DTPA-extractable 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oil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Zn, root DW, root length, average root diameter, shoot DW, shoot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Zn concentrations,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tate:Zn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molar ratio and shoot protein concentration in </a:t>
            </a:r>
            <a:r>
              <a:rPr lang="en-AU" sz="1200" b="1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kumimoji="0" lang="en-GB" sz="12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bterraneum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s-E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51520" y="6135687"/>
            <a:ext cx="437042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 Detection limit &lt; 0.002 mg kg</a:t>
            </a:r>
            <a:r>
              <a:rPr kumimoji="0" lang="en-GB" sz="1200" b="0" i="0" u="none" strike="noStrike" cap="none" normalizeH="0" baseline="3000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for soil DTPA-extractable soil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Cd</a:t>
            </a:r>
            <a:endParaRPr kumimoji="0" lang="es-ES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* Detection limit &lt; 0.05 mg kg</a:t>
            </a:r>
            <a:r>
              <a:rPr kumimoji="0" lang="en-GB" sz="1200" b="0" i="0" u="none" strike="noStrike" cap="none" normalizeH="0" baseline="3000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-1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for digested plants</a:t>
            </a:r>
            <a:endParaRPr kumimoji="0" lang="en-GB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3</TotalTime>
  <Words>480</Words>
  <Application>Microsoft Office PowerPoint</Application>
  <PresentationFormat>Presentación en pantalla (4:3)</PresentationFormat>
  <Paragraphs>16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ria jose</dc:creator>
  <cp:lastModifiedBy>usuario</cp:lastModifiedBy>
  <cp:revision>26</cp:revision>
  <dcterms:modified xsi:type="dcterms:W3CDTF">2017-09-15T09:00:46Z</dcterms:modified>
</cp:coreProperties>
</file>